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1/11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1/11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Relation between obesity-related comorbidities and </a:t>
            </a:r>
          </a:p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kidney function estimation in children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883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Different creatinine-based GFR equations demonstrate different correlations with obesity-related comorbidities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van Dam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29979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Correlations between obesity-related comorbidities and estimated kidney function can be found in children with overweight and obesity, but depend on the eGFR equation of choice. SCr/Q can be used as an alternative for eGFR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1" name="TextBox 32"/>
          <p:cNvSpPr txBox="1"/>
          <p:nvPr/>
        </p:nvSpPr>
        <p:spPr>
          <a:xfrm>
            <a:off x="1025370" y="2205258"/>
            <a:ext cx="3245840" cy="1323439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GB" sz="1600" dirty="0">
                <a:solidFill>
                  <a:srgbClr val="296DC0"/>
                </a:solidFill>
              </a:rPr>
              <a:t>600 children with overweight and obesity without overt kidney disease </a:t>
            </a:r>
          </a:p>
          <a:p>
            <a:pPr lvl="1"/>
            <a:r>
              <a:rPr lang="en-GB" sz="1600" dirty="0">
                <a:solidFill>
                  <a:srgbClr val="296DC0"/>
                </a:solidFill>
              </a:rPr>
              <a:t>53.5% female</a:t>
            </a:r>
          </a:p>
          <a:p>
            <a:pPr lvl="1"/>
            <a:r>
              <a:rPr lang="en-GB" sz="1600" dirty="0">
                <a:solidFill>
                  <a:srgbClr val="296DC0"/>
                </a:solidFill>
              </a:rPr>
              <a:t>Mean age: 12.20 ± 3.28 year</a:t>
            </a:r>
          </a:p>
          <a:p>
            <a:pPr lvl="1"/>
            <a:r>
              <a:rPr lang="en-GB" sz="1600" dirty="0">
                <a:solidFill>
                  <a:srgbClr val="296DC0"/>
                </a:solidFill>
              </a:rPr>
              <a:t>Mean BMI z-score 3.31 ± 0.75 </a:t>
            </a:r>
          </a:p>
        </p:txBody>
      </p:sp>
      <p:pic>
        <p:nvPicPr>
          <p:cNvPr id="19" name="pasted-image.pdf" descr="pasted-image.pdf"/>
          <p:cNvPicPr>
            <a:picLocks noChangeAspect="1"/>
          </p:cNvPicPr>
          <p:nvPr/>
        </p:nvPicPr>
        <p:blipFill>
          <a:blip r:embed="rId2">
            <a:extLst/>
          </a:blip>
          <a:stretch>
            <a:fillRect/>
          </a:stretch>
        </p:blipFill>
        <p:spPr>
          <a:xfrm>
            <a:off x="4544926" y="2221212"/>
            <a:ext cx="721554" cy="886733"/>
          </a:xfrm>
          <a:prstGeom prst="rect">
            <a:avLst/>
          </a:prstGeom>
          <a:ln w="12700">
            <a:miter lim="400000"/>
          </a:ln>
        </p:spPr>
      </p:pic>
      <p:sp>
        <p:nvSpPr>
          <p:cNvPr id="21" name="TextBox 32"/>
          <p:cNvSpPr txBox="1"/>
          <p:nvPr/>
        </p:nvSpPr>
        <p:spPr>
          <a:xfrm>
            <a:off x="1025242" y="4462578"/>
            <a:ext cx="3246095" cy="830997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GB" sz="1600" dirty="0">
                <a:solidFill>
                  <a:srgbClr val="296DC0"/>
                </a:solidFill>
              </a:rPr>
              <a:t>Comprehensive clinical assessment to assess possible obesity-related comorbidities</a:t>
            </a:r>
          </a:p>
        </p:txBody>
      </p:sp>
      <p:pic>
        <p:nvPicPr>
          <p:cNvPr id="30" name="pasted-image.pdf" descr="pasted-image.pdf"/>
          <p:cNvPicPr>
            <a:picLocks noChangeAspect="1"/>
          </p:cNvPicPr>
          <p:nvPr/>
        </p:nvPicPr>
        <p:blipFill>
          <a:blip r:embed="rId3">
            <a:extLst/>
          </a:blip>
          <a:stretch>
            <a:fillRect/>
          </a:stretch>
        </p:blipFill>
        <p:spPr>
          <a:xfrm>
            <a:off x="4544926" y="4810036"/>
            <a:ext cx="721554" cy="483539"/>
          </a:xfrm>
          <a:prstGeom prst="rect">
            <a:avLst/>
          </a:prstGeom>
          <a:ln w="12700">
            <a:miter lim="400000"/>
          </a:ln>
        </p:spPr>
      </p:pic>
      <p:grpSp>
        <p:nvGrpSpPr>
          <p:cNvPr id="5" name="Groep 4"/>
          <p:cNvGrpSpPr/>
          <p:nvPr/>
        </p:nvGrpSpPr>
        <p:grpSpPr>
          <a:xfrm>
            <a:off x="4544926" y="3712299"/>
            <a:ext cx="721554" cy="563998"/>
            <a:chOff x="1951433" y="3842545"/>
            <a:chExt cx="2472228" cy="1932402"/>
          </a:xfrm>
        </p:grpSpPr>
        <p:sp>
          <p:nvSpPr>
            <p:cNvPr id="31" name="Maatbeker"/>
            <p:cNvSpPr/>
            <p:nvPr/>
          </p:nvSpPr>
          <p:spPr>
            <a:xfrm>
              <a:off x="1951433" y="3842545"/>
              <a:ext cx="1341960" cy="1932402"/>
            </a:xfrm>
            <a:custGeom>
              <a:avLst/>
              <a:gdLst/>
              <a:ahLst/>
              <a:cxnLst>
                <a:cxn ang="0">
                  <a:pos x="wd2" y="hd2"/>
                </a:cxn>
                <a:cxn ang="5400000">
                  <a:pos x="wd2" y="hd2"/>
                </a:cxn>
                <a:cxn ang="10800000">
                  <a:pos x="wd2" y="hd2"/>
                </a:cxn>
                <a:cxn ang="16200000">
                  <a:pos x="wd2" y="hd2"/>
                </a:cxn>
              </a:cxnLst>
              <a:rect l="0" t="0" r="r" b="b"/>
              <a:pathLst>
                <a:path w="21295" h="21600" extrusionOk="0">
                  <a:moveTo>
                    <a:pt x="7609" y="0"/>
                  </a:moveTo>
                  <a:cubicBezTo>
                    <a:pt x="7178" y="0"/>
                    <a:pt x="6826" y="248"/>
                    <a:pt x="6826" y="552"/>
                  </a:cubicBezTo>
                  <a:cubicBezTo>
                    <a:pt x="6826" y="856"/>
                    <a:pt x="7178" y="1104"/>
                    <a:pt x="7609" y="1104"/>
                  </a:cubicBezTo>
                  <a:lnTo>
                    <a:pt x="7978" y="1104"/>
                  </a:lnTo>
                  <a:lnTo>
                    <a:pt x="7978" y="5587"/>
                  </a:lnTo>
                  <a:lnTo>
                    <a:pt x="53" y="20785"/>
                  </a:lnTo>
                  <a:cubicBezTo>
                    <a:pt x="-153" y="21181"/>
                    <a:pt x="264" y="21600"/>
                    <a:pt x="863" y="21600"/>
                  </a:cubicBezTo>
                  <a:lnTo>
                    <a:pt x="20433" y="21600"/>
                  </a:lnTo>
                  <a:cubicBezTo>
                    <a:pt x="21032" y="21600"/>
                    <a:pt x="21447" y="21181"/>
                    <a:pt x="21241" y="20785"/>
                  </a:cubicBezTo>
                  <a:lnTo>
                    <a:pt x="13318" y="5587"/>
                  </a:lnTo>
                  <a:lnTo>
                    <a:pt x="13318" y="1104"/>
                  </a:lnTo>
                  <a:lnTo>
                    <a:pt x="13687" y="1104"/>
                  </a:lnTo>
                  <a:cubicBezTo>
                    <a:pt x="14119" y="1104"/>
                    <a:pt x="14470" y="856"/>
                    <a:pt x="14470" y="552"/>
                  </a:cubicBezTo>
                  <a:cubicBezTo>
                    <a:pt x="14470" y="248"/>
                    <a:pt x="14119" y="0"/>
                    <a:pt x="13687" y="0"/>
                  </a:cubicBezTo>
                  <a:lnTo>
                    <a:pt x="7609" y="0"/>
                  </a:lnTo>
                  <a:close/>
                  <a:moveTo>
                    <a:pt x="9109" y="7347"/>
                  </a:moveTo>
                  <a:lnTo>
                    <a:pt x="12202" y="7347"/>
                  </a:lnTo>
                  <a:lnTo>
                    <a:pt x="12202" y="7725"/>
                  </a:lnTo>
                  <a:lnTo>
                    <a:pt x="9109" y="7725"/>
                  </a:lnTo>
                  <a:lnTo>
                    <a:pt x="9109" y="7347"/>
                  </a:lnTo>
                  <a:close/>
                  <a:moveTo>
                    <a:pt x="10498" y="8383"/>
                  </a:moveTo>
                  <a:lnTo>
                    <a:pt x="12199" y="8383"/>
                  </a:lnTo>
                  <a:lnTo>
                    <a:pt x="12199" y="8761"/>
                  </a:lnTo>
                  <a:lnTo>
                    <a:pt x="10498" y="8761"/>
                  </a:lnTo>
                  <a:lnTo>
                    <a:pt x="10498" y="8383"/>
                  </a:lnTo>
                  <a:close/>
                  <a:moveTo>
                    <a:pt x="10498" y="9420"/>
                  </a:moveTo>
                  <a:lnTo>
                    <a:pt x="12199" y="9420"/>
                  </a:lnTo>
                  <a:lnTo>
                    <a:pt x="12199" y="9798"/>
                  </a:lnTo>
                  <a:lnTo>
                    <a:pt x="10498" y="9798"/>
                  </a:lnTo>
                  <a:lnTo>
                    <a:pt x="10498" y="9420"/>
                  </a:lnTo>
                  <a:close/>
                  <a:moveTo>
                    <a:pt x="10496" y="10457"/>
                  </a:moveTo>
                  <a:lnTo>
                    <a:pt x="12197" y="10457"/>
                  </a:lnTo>
                  <a:lnTo>
                    <a:pt x="12197" y="10834"/>
                  </a:lnTo>
                  <a:lnTo>
                    <a:pt x="10496" y="10834"/>
                  </a:lnTo>
                  <a:lnTo>
                    <a:pt x="10496" y="10457"/>
                  </a:lnTo>
                  <a:close/>
                  <a:moveTo>
                    <a:pt x="9104" y="11494"/>
                  </a:moveTo>
                  <a:lnTo>
                    <a:pt x="12197" y="11494"/>
                  </a:lnTo>
                  <a:lnTo>
                    <a:pt x="12197" y="11870"/>
                  </a:lnTo>
                  <a:lnTo>
                    <a:pt x="9104" y="11870"/>
                  </a:lnTo>
                  <a:lnTo>
                    <a:pt x="9104" y="11494"/>
                  </a:lnTo>
                  <a:close/>
                  <a:moveTo>
                    <a:pt x="10494" y="12530"/>
                  </a:moveTo>
                  <a:lnTo>
                    <a:pt x="12195" y="12530"/>
                  </a:lnTo>
                  <a:lnTo>
                    <a:pt x="12195" y="12906"/>
                  </a:lnTo>
                  <a:lnTo>
                    <a:pt x="10494" y="12906"/>
                  </a:lnTo>
                  <a:lnTo>
                    <a:pt x="10494" y="12530"/>
                  </a:lnTo>
                  <a:close/>
                  <a:moveTo>
                    <a:pt x="10494" y="13566"/>
                  </a:moveTo>
                  <a:lnTo>
                    <a:pt x="12195" y="13566"/>
                  </a:lnTo>
                  <a:lnTo>
                    <a:pt x="12195" y="13944"/>
                  </a:lnTo>
                  <a:lnTo>
                    <a:pt x="10494" y="13944"/>
                  </a:lnTo>
                  <a:lnTo>
                    <a:pt x="10494" y="13566"/>
                  </a:lnTo>
                  <a:close/>
                  <a:moveTo>
                    <a:pt x="10491" y="14602"/>
                  </a:moveTo>
                  <a:lnTo>
                    <a:pt x="12195" y="14602"/>
                  </a:lnTo>
                  <a:lnTo>
                    <a:pt x="12192" y="14980"/>
                  </a:lnTo>
                  <a:lnTo>
                    <a:pt x="10491" y="14980"/>
                  </a:lnTo>
                  <a:lnTo>
                    <a:pt x="10491" y="14602"/>
                  </a:lnTo>
                  <a:close/>
                  <a:moveTo>
                    <a:pt x="9099" y="15638"/>
                  </a:moveTo>
                  <a:lnTo>
                    <a:pt x="12192" y="15638"/>
                  </a:lnTo>
                  <a:lnTo>
                    <a:pt x="12192" y="16016"/>
                  </a:lnTo>
                  <a:lnTo>
                    <a:pt x="9099" y="16016"/>
                  </a:lnTo>
                  <a:lnTo>
                    <a:pt x="9099" y="15638"/>
                  </a:lnTo>
                  <a:close/>
                  <a:moveTo>
                    <a:pt x="10489" y="16674"/>
                  </a:moveTo>
                  <a:lnTo>
                    <a:pt x="12192" y="16674"/>
                  </a:lnTo>
                  <a:lnTo>
                    <a:pt x="12190" y="17052"/>
                  </a:lnTo>
                  <a:lnTo>
                    <a:pt x="10489" y="17052"/>
                  </a:lnTo>
                  <a:lnTo>
                    <a:pt x="10489" y="16674"/>
                  </a:lnTo>
                  <a:close/>
                  <a:moveTo>
                    <a:pt x="10489" y="17710"/>
                  </a:moveTo>
                  <a:lnTo>
                    <a:pt x="12190" y="17710"/>
                  </a:lnTo>
                  <a:lnTo>
                    <a:pt x="12190" y="18088"/>
                  </a:lnTo>
                  <a:lnTo>
                    <a:pt x="10489" y="18088"/>
                  </a:lnTo>
                  <a:lnTo>
                    <a:pt x="10489" y="17710"/>
                  </a:lnTo>
                  <a:close/>
                  <a:moveTo>
                    <a:pt x="10489" y="18746"/>
                  </a:moveTo>
                  <a:lnTo>
                    <a:pt x="12190" y="18746"/>
                  </a:lnTo>
                  <a:lnTo>
                    <a:pt x="12187" y="19124"/>
                  </a:lnTo>
                  <a:lnTo>
                    <a:pt x="10486" y="19124"/>
                  </a:lnTo>
                  <a:lnTo>
                    <a:pt x="10489" y="18746"/>
                  </a:lnTo>
                  <a:close/>
                  <a:moveTo>
                    <a:pt x="9095" y="19783"/>
                  </a:moveTo>
                  <a:lnTo>
                    <a:pt x="12187" y="19783"/>
                  </a:lnTo>
                  <a:lnTo>
                    <a:pt x="12187" y="20161"/>
                  </a:lnTo>
                  <a:lnTo>
                    <a:pt x="9095" y="20161"/>
                  </a:lnTo>
                  <a:lnTo>
                    <a:pt x="9095" y="19783"/>
                  </a:lnTo>
                  <a:close/>
                </a:path>
              </a:pathLst>
            </a:custGeom>
            <a:solidFill>
              <a:srgbClr val="DC7B30"/>
            </a:solidFill>
            <a:ln w="12700">
              <a:miter lim="400000"/>
            </a:ln>
          </p:spPr>
          <p:txBody>
            <a:bodyPr lIns="0" tIns="0" rIns="0" bIns="0" anchor="ctr"/>
            <a:lstStyle/>
            <a:p>
              <a:pPr>
                <a:defRPr sz="3200">
                  <a:solidFill>
                    <a:srgbClr val="FFFFFF"/>
                  </a:solidFill>
                </a:defRPr>
              </a:pPr>
              <a:endParaRPr dirty="0"/>
            </a:p>
          </p:txBody>
        </p:sp>
        <p:sp>
          <p:nvSpPr>
            <p:cNvPr id="32" name="Reageerbuis"/>
            <p:cNvSpPr/>
            <p:nvPr/>
          </p:nvSpPr>
          <p:spPr>
            <a:xfrm>
              <a:off x="3942058" y="3842545"/>
              <a:ext cx="481603" cy="1932402"/>
            </a:xfrm>
            <a:custGeom>
              <a:avLst/>
              <a:gdLst/>
              <a:ahLst/>
              <a:cxnLst>
                <a:cxn ang="0">
                  <a:pos x="wd2" y="hd2"/>
                </a:cxn>
                <a:cxn ang="5400000">
                  <a:pos x="wd2" y="hd2"/>
                </a:cxn>
                <a:cxn ang="10800000">
                  <a:pos x="wd2" y="hd2"/>
                </a:cxn>
                <a:cxn ang="16200000">
                  <a:pos x="wd2" y="hd2"/>
                </a:cxn>
              </a:cxnLst>
              <a:rect l="0" t="0" r="r" b="b"/>
              <a:pathLst>
                <a:path w="21600" h="21600" extrusionOk="0">
                  <a:moveTo>
                    <a:pt x="2212" y="0"/>
                  </a:moveTo>
                  <a:cubicBezTo>
                    <a:pt x="992" y="0"/>
                    <a:pt x="0" y="247"/>
                    <a:pt x="0" y="551"/>
                  </a:cubicBezTo>
                  <a:cubicBezTo>
                    <a:pt x="0" y="855"/>
                    <a:pt x="992" y="1102"/>
                    <a:pt x="2212" y="1102"/>
                  </a:cubicBezTo>
                  <a:lnTo>
                    <a:pt x="3254" y="1102"/>
                  </a:lnTo>
                  <a:lnTo>
                    <a:pt x="3254" y="19720"/>
                  </a:lnTo>
                  <a:cubicBezTo>
                    <a:pt x="3254" y="20758"/>
                    <a:pt x="6630" y="21600"/>
                    <a:pt x="10797" y="21600"/>
                  </a:cubicBezTo>
                  <a:cubicBezTo>
                    <a:pt x="14963" y="21600"/>
                    <a:pt x="18339" y="20758"/>
                    <a:pt x="18339" y="19720"/>
                  </a:cubicBezTo>
                  <a:lnTo>
                    <a:pt x="18339" y="19347"/>
                  </a:lnTo>
                  <a:lnTo>
                    <a:pt x="8632" y="19347"/>
                  </a:lnTo>
                  <a:lnTo>
                    <a:pt x="8632" y="18968"/>
                  </a:lnTo>
                  <a:lnTo>
                    <a:pt x="18339" y="18968"/>
                  </a:lnTo>
                  <a:lnTo>
                    <a:pt x="18339" y="18055"/>
                  </a:lnTo>
                  <a:lnTo>
                    <a:pt x="13116" y="18055"/>
                  </a:lnTo>
                  <a:lnTo>
                    <a:pt x="13116" y="17678"/>
                  </a:lnTo>
                  <a:lnTo>
                    <a:pt x="18339" y="17678"/>
                  </a:lnTo>
                  <a:lnTo>
                    <a:pt x="18339" y="16765"/>
                  </a:lnTo>
                  <a:lnTo>
                    <a:pt x="13116" y="16765"/>
                  </a:lnTo>
                  <a:lnTo>
                    <a:pt x="13116" y="16386"/>
                  </a:lnTo>
                  <a:lnTo>
                    <a:pt x="18339" y="16386"/>
                  </a:lnTo>
                  <a:lnTo>
                    <a:pt x="18339" y="15473"/>
                  </a:lnTo>
                  <a:lnTo>
                    <a:pt x="13116" y="15473"/>
                  </a:lnTo>
                  <a:lnTo>
                    <a:pt x="13116" y="15096"/>
                  </a:lnTo>
                  <a:lnTo>
                    <a:pt x="18339" y="15096"/>
                  </a:lnTo>
                  <a:lnTo>
                    <a:pt x="18339" y="14183"/>
                  </a:lnTo>
                  <a:lnTo>
                    <a:pt x="8632" y="14183"/>
                  </a:lnTo>
                  <a:lnTo>
                    <a:pt x="8632" y="13804"/>
                  </a:lnTo>
                  <a:lnTo>
                    <a:pt x="18339" y="13804"/>
                  </a:lnTo>
                  <a:lnTo>
                    <a:pt x="18339" y="12891"/>
                  </a:lnTo>
                  <a:lnTo>
                    <a:pt x="13116" y="12891"/>
                  </a:lnTo>
                  <a:lnTo>
                    <a:pt x="13116" y="12514"/>
                  </a:lnTo>
                  <a:lnTo>
                    <a:pt x="18339" y="12514"/>
                  </a:lnTo>
                  <a:lnTo>
                    <a:pt x="18339" y="11601"/>
                  </a:lnTo>
                  <a:lnTo>
                    <a:pt x="13116" y="11601"/>
                  </a:lnTo>
                  <a:lnTo>
                    <a:pt x="13116" y="11222"/>
                  </a:lnTo>
                  <a:lnTo>
                    <a:pt x="18339" y="11222"/>
                  </a:lnTo>
                  <a:lnTo>
                    <a:pt x="18339" y="10309"/>
                  </a:lnTo>
                  <a:lnTo>
                    <a:pt x="13116" y="10309"/>
                  </a:lnTo>
                  <a:lnTo>
                    <a:pt x="13116" y="9932"/>
                  </a:lnTo>
                  <a:lnTo>
                    <a:pt x="18339" y="9932"/>
                  </a:lnTo>
                  <a:lnTo>
                    <a:pt x="18339" y="9019"/>
                  </a:lnTo>
                  <a:lnTo>
                    <a:pt x="8632" y="9019"/>
                  </a:lnTo>
                  <a:lnTo>
                    <a:pt x="8632" y="8640"/>
                  </a:lnTo>
                  <a:lnTo>
                    <a:pt x="18339" y="8640"/>
                  </a:lnTo>
                  <a:lnTo>
                    <a:pt x="18339" y="7727"/>
                  </a:lnTo>
                  <a:lnTo>
                    <a:pt x="13116" y="7727"/>
                  </a:lnTo>
                  <a:lnTo>
                    <a:pt x="13116" y="7350"/>
                  </a:lnTo>
                  <a:lnTo>
                    <a:pt x="18339" y="7350"/>
                  </a:lnTo>
                  <a:lnTo>
                    <a:pt x="18339" y="6437"/>
                  </a:lnTo>
                  <a:lnTo>
                    <a:pt x="13116" y="6437"/>
                  </a:lnTo>
                  <a:lnTo>
                    <a:pt x="13116" y="6058"/>
                  </a:lnTo>
                  <a:lnTo>
                    <a:pt x="18339" y="6058"/>
                  </a:lnTo>
                  <a:lnTo>
                    <a:pt x="18339" y="5145"/>
                  </a:lnTo>
                  <a:lnTo>
                    <a:pt x="13116" y="5145"/>
                  </a:lnTo>
                  <a:lnTo>
                    <a:pt x="13116" y="4768"/>
                  </a:lnTo>
                  <a:lnTo>
                    <a:pt x="18339" y="4768"/>
                  </a:lnTo>
                  <a:lnTo>
                    <a:pt x="18339" y="3855"/>
                  </a:lnTo>
                  <a:lnTo>
                    <a:pt x="8632" y="3855"/>
                  </a:lnTo>
                  <a:lnTo>
                    <a:pt x="8632" y="3477"/>
                  </a:lnTo>
                  <a:lnTo>
                    <a:pt x="18339" y="3477"/>
                  </a:lnTo>
                  <a:lnTo>
                    <a:pt x="18339" y="1102"/>
                  </a:lnTo>
                  <a:lnTo>
                    <a:pt x="19388" y="1102"/>
                  </a:lnTo>
                  <a:cubicBezTo>
                    <a:pt x="20608" y="1102"/>
                    <a:pt x="21600" y="855"/>
                    <a:pt x="21600" y="551"/>
                  </a:cubicBezTo>
                  <a:cubicBezTo>
                    <a:pt x="21600" y="247"/>
                    <a:pt x="20608" y="0"/>
                    <a:pt x="19388" y="0"/>
                  </a:cubicBezTo>
                  <a:lnTo>
                    <a:pt x="2212" y="0"/>
                  </a:lnTo>
                  <a:close/>
                </a:path>
              </a:pathLst>
            </a:custGeom>
            <a:solidFill>
              <a:srgbClr val="DC7B30"/>
            </a:solidFill>
            <a:ln w="12700">
              <a:miter lim="400000"/>
            </a:ln>
          </p:spPr>
          <p:txBody>
            <a:bodyPr lIns="0" tIns="0" rIns="0" bIns="0" anchor="ctr"/>
            <a:lstStyle/>
            <a:p>
              <a:pPr>
                <a:defRPr sz="3200">
                  <a:solidFill>
                    <a:srgbClr val="FFFFFF"/>
                  </a:solidFill>
                </a:defRPr>
              </a:pPr>
              <a:endParaRPr dirty="0"/>
            </a:p>
          </p:txBody>
        </p:sp>
      </p:grpSp>
      <p:sp>
        <p:nvSpPr>
          <p:cNvPr id="33" name="Rechthoek 32"/>
          <p:cNvSpPr/>
          <p:nvPr/>
        </p:nvSpPr>
        <p:spPr>
          <a:xfrm>
            <a:off x="5474764" y="2199844"/>
            <a:ext cx="6445618" cy="923330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bg1"/>
            </a:solidFill>
          </a:ln>
        </p:spPr>
        <p:txBody>
          <a:bodyPr wrap="square">
            <a:spAutoFit/>
          </a:bodyPr>
          <a:lstStyle/>
          <a:p>
            <a:r>
              <a:rPr lang="en-US" dirty="0">
                <a:solidFill>
                  <a:srgbClr val="00437A"/>
                </a:solidFill>
              </a:rPr>
              <a:t>Correlation with fat mass and waist-to-hip ratio suggesting a relation between central adiposity and kidney function in children with overweight and obesity.</a:t>
            </a:r>
          </a:p>
        </p:txBody>
      </p:sp>
      <p:sp>
        <p:nvSpPr>
          <p:cNvPr id="2" name="Rechthoek 1"/>
          <p:cNvSpPr/>
          <p:nvPr/>
        </p:nvSpPr>
        <p:spPr>
          <a:xfrm>
            <a:off x="1037147" y="4708099"/>
            <a:ext cx="6096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endParaRPr lang="en-GB" dirty="0">
              <a:solidFill>
                <a:srgbClr val="296DC0"/>
              </a:solidFill>
            </a:endParaRPr>
          </a:p>
        </p:txBody>
      </p:sp>
      <p:sp>
        <p:nvSpPr>
          <p:cNvPr id="6" name="Rechthoek 5"/>
          <p:cNvSpPr/>
          <p:nvPr/>
        </p:nvSpPr>
        <p:spPr>
          <a:xfrm>
            <a:off x="5474764" y="3255634"/>
            <a:ext cx="6445617" cy="1477328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>
            <a:spAutoFit/>
          </a:bodyPr>
          <a:lstStyle/>
          <a:p>
            <a:r>
              <a:rPr lang="en-US" dirty="0">
                <a:solidFill>
                  <a:srgbClr val="00437A"/>
                </a:solidFill>
              </a:rPr>
              <a:t>SCr/Q and nearly all eGFR equations correlated with HOMA-IR and HDL-cholesterol, triacylglyceride, serum uric acid and ALT concentrations. Apart from this, there is a major inconsistency between eGFR equations and (weak) correlations with metabolic variables.</a:t>
            </a:r>
          </a:p>
        </p:txBody>
      </p:sp>
      <p:sp>
        <p:nvSpPr>
          <p:cNvPr id="7" name="Rechthoek 6"/>
          <p:cNvSpPr/>
          <p:nvPr/>
        </p:nvSpPr>
        <p:spPr>
          <a:xfrm>
            <a:off x="5474636" y="4870006"/>
            <a:ext cx="6445745" cy="36933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>
            <a:spAutoFit/>
          </a:bodyPr>
          <a:lstStyle/>
          <a:p>
            <a:r>
              <a:rPr lang="en-US" dirty="0">
                <a:solidFill>
                  <a:srgbClr val="00437A"/>
                </a:solidFill>
              </a:rPr>
              <a:t>SCr/Q can be a valuable alternative for eGFR.</a:t>
            </a:r>
            <a:endParaRPr lang="en-US" sz="1600" dirty="0">
              <a:solidFill>
                <a:srgbClr val="00437A"/>
              </a:solidFill>
            </a:endParaRPr>
          </a:p>
        </p:txBody>
      </p:sp>
      <p:grpSp>
        <p:nvGrpSpPr>
          <p:cNvPr id="35" name="Groep 34"/>
          <p:cNvGrpSpPr/>
          <p:nvPr/>
        </p:nvGrpSpPr>
        <p:grpSpPr>
          <a:xfrm>
            <a:off x="173448" y="2504789"/>
            <a:ext cx="756963" cy="743738"/>
            <a:chOff x="180182" y="3061181"/>
            <a:chExt cx="1279390" cy="1176091"/>
          </a:xfrm>
        </p:grpSpPr>
        <p:sp>
          <p:nvSpPr>
            <p:cNvPr id="36" name="Freeform: Shape 46">
              <a:extLst>
                <a:ext uri="{FF2B5EF4-FFF2-40B4-BE49-F238E27FC236}">
                  <a16:creationId xmlns:a16="http://schemas.microsoft.com/office/drawing/2014/main" id="{398CC7CE-E349-47F6-A657-57A404826369}"/>
                </a:ext>
              </a:extLst>
            </p:cNvPr>
            <p:cNvSpPr/>
            <p:nvPr/>
          </p:nvSpPr>
          <p:spPr>
            <a:xfrm>
              <a:off x="180182" y="3072666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296DC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42" name="Freeform: Shape 46">
              <a:extLst>
                <a:ext uri="{FF2B5EF4-FFF2-40B4-BE49-F238E27FC236}">
                  <a16:creationId xmlns:a16="http://schemas.microsoft.com/office/drawing/2014/main" id="{398CC7CE-E349-47F6-A657-57A404826369}"/>
                </a:ext>
              </a:extLst>
            </p:cNvPr>
            <p:cNvSpPr/>
            <p:nvPr/>
          </p:nvSpPr>
          <p:spPr>
            <a:xfrm>
              <a:off x="424856" y="3187374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44" name="Freeform: Shape 46">
              <a:extLst>
                <a:ext uri="{FF2B5EF4-FFF2-40B4-BE49-F238E27FC236}">
                  <a16:creationId xmlns:a16="http://schemas.microsoft.com/office/drawing/2014/main" id="{398CC7CE-E349-47F6-A657-57A404826369}"/>
                </a:ext>
              </a:extLst>
            </p:cNvPr>
            <p:cNvSpPr/>
            <p:nvPr/>
          </p:nvSpPr>
          <p:spPr>
            <a:xfrm>
              <a:off x="630181" y="3061181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296DC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45" name="Freeform: Shape 46">
              <a:extLst>
                <a:ext uri="{FF2B5EF4-FFF2-40B4-BE49-F238E27FC236}">
                  <a16:creationId xmlns:a16="http://schemas.microsoft.com/office/drawing/2014/main" id="{398CC7CE-E349-47F6-A657-57A404826369}"/>
                </a:ext>
              </a:extLst>
            </p:cNvPr>
            <p:cNvSpPr/>
            <p:nvPr/>
          </p:nvSpPr>
          <p:spPr>
            <a:xfrm>
              <a:off x="946288" y="3187374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</p:grpSp>
      <p:sp>
        <p:nvSpPr>
          <p:cNvPr id="8" name="Rechthoek 7"/>
          <p:cNvSpPr/>
          <p:nvPr/>
        </p:nvSpPr>
        <p:spPr>
          <a:xfrm>
            <a:off x="1025114" y="3703250"/>
            <a:ext cx="3311529" cy="584775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</p:spPr>
        <p:txBody>
          <a:bodyPr wrap="square">
            <a:spAutoFit/>
          </a:bodyPr>
          <a:lstStyle/>
          <a:p>
            <a:r>
              <a:rPr lang="en-GB" sz="1600" dirty="0">
                <a:solidFill>
                  <a:srgbClr val="296DC0"/>
                </a:solidFill>
              </a:rPr>
              <a:t>Rescaled creatinine for sex and age or height (SCr/Qage and SCr/Qheight)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202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7</cp:revision>
  <dcterms:created xsi:type="dcterms:W3CDTF">2019-06-13T12:30:18Z</dcterms:created>
  <dcterms:modified xsi:type="dcterms:W3CDTF">2022-11-01T19:38:41Z</dcterms:modified>
</cp:coreProperties>
</file>